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3924A0-144F-4EC4-8130-CC5FE24BA741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23E2B1-CEA7-4AF5-AD4B-DD1E32BEA1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587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C1F5E0-2329-4367-9BA7-E2ACCFAD3C5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846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1DB87-9BF3-4C9E-8ECD-65049E9076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103AE1-F0B4-460C-99E8-26A76A00B6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BFDDD-DCCF-49B2-AB33-BFF023766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6B9E73-3132-4213-957C-BBF34D279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E90B9A-1722-4DA2-B9D6-03ED34A81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905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95774-1636-4731-A9CE-4100FD8D4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E20A49-B201-41AC-834B-49F252B290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0367B4-87C5-43E5-A2A4-AE9DFB400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6B3E29-81D7-4034-8033-9B5D82F06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6FEEC-83B9-49D7-86BD-5E43070BC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98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8F134F-3EA5-4396-A9A4-CB6CB1BA5F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10E11C-9AE2-46AC-83B6-D81F30A551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E48C6D-0E95-426F-A5A0-208370640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C8C749-20B7-485B-B160-7A191C18B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2DD605-C986-4E77-8619-226E98486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66403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39786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9F077-D6FC-4A83-B5C0-1298ADB61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EB41E9-0B19-4A19-BA62-36FCAB0099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96760F-683F-4E12-B00F-6D5E86782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64ACA5-C35D-451D-8CA6-6480AEC5C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15B85D-587B-4403-A955-B1A200B36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984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DD383-F138-4344-9841-89EAA4F330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ACB61F-B1B8-41CB-B2C8-B09F63A9BB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6AE16E-4584-4ADB-8C8B-00ADECB23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739758-BA13-4D57-8012-A60E985A7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CE727E-2C4E-4CEC-B1E3-EDCC5FF43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180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2BC99C-382D-4F17-8971-7FFAE4DBAA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4D71E3-25A5-4CDE-A38D-363331BAB9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618E13-BD7A-41C1-84F8-1CC57A12E6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B45095-CCB8-4E29-B10D-937C2F47A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87B88B-A3A4-4EC1-A826-3FCFE44A9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3930BF-DFF9-4216-8C46-CDC66673C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835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E45971-52F7-4C69-AB78-22FE739097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9BA3DB-3B7C-4689-89E1-0295A32DA5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29501C-2C24-4138-ACBD-F0210C13FB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4E1A5E-CC95-4FA3-88F3-94B9780597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0279D3-4C03-41E0-8929-6BA012AB01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1B4A93-9EC2-4066-8609-895FB43BF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7584FC-DB8D-4FE4-B55A-ADC31CA0D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16089C-5F19-43DB-BA59-EC35BDC9E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873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23045-6749-458C-9D9D-AEA13B63C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BBF513-5859-4FB5-883C-74AF494BB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3BBA61-E952-4827-8015-546A8C3AC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17D1F8-2836-4127-BC7D-D29958473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029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15BA36-ACAB-4474-A9FF-DBB384790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319C27-92FF-4016-9B64-4064E3397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2B9459-8652-4B8E-8F2D-D60346DEA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443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F4644-3803-4F3B-BF6C-BA5A7C04F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DFFD73-A1FA-402A-A7A8-F3A6CCA0A2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AA1D5B-78DE-4C0A-9279-9A7EAAE755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13F630-C451-4A10-8109-CD4B3AD07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5B9204-C519-4413-9FC0-12416B382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2C4CEE-3E82-49A1-A848-BCB32C958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347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98401-0EA3-459C-8E49-917C45D27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1D5C53-732C-41E2-AE8B-73BCD7A465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15F0B5-B982-4091-9621-68F0E6BA47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E4A40A-D06C-4B39-A248-738FCD7EE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0121E8-407F-4CC5-B9F0-2A1A81645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866AAF-7DE5-42A2-AA38-B6D81EC67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09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6B077B-C111-4BEC-828A-74E287ECF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C9D855-2814-4949-B700-7D63ED8EB3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FD539C-D1EC-4F2C-9C25-F5CAA809B4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C29131-1F9F-4F24-96B1-706DDD474C8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129ABD-062A-44F4-9B70-BF24508585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77BA83-96CD-4244-A3E3-FD0F6A250E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59AFF-822E-4094-8D42-EC69201F97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536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notesSlide" Target="../notesSlides/notesSlide1.xml"/><Relationship Id="rId7" Type="http://schemas.microsoft.com/office/2007/relationships/hdphoto" Target="../media/hdphoto1.wdp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11" Type="http://schemas.openxmlformats.org/officeDocument/2006/relationships/image" Target="../media/image2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2.bin"/><Relationship Id="rId4" Type="http://schemas.openxmlformats.org/officeDocument/2006/relationships/oleObject" Target="../embeddings/oleObject1.bin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05A69101-1784-4036-8558-EC3A705D193A}"/>
              </a:ext>
            </a:extLst>
          </p:cNvPr>
          <p:cNvGrpSpPr/>
          <p:nvPr/>
        </p:nvGrpSpPr>
        <p:grpSpPr>
          <a:xfrm>
            <a:off x="2908263" y="1150656"/>
            <a:ext cx="5613117" cy="4556687"/>
            <a:chOff x="848643" y="903304"/>
            <a:chExt cx="5613117" cy="455668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B7CD452-2D3E-4529-9220-C879B8A38285}"/>
                </a:ext>
              </a:extLst>
            </p:cNvPr>
            <p:cNvGrpSpPr/>
            <p:nvPr/>
          </p:nvGrpSpPr>
          <p:grpSpPr>
            <a:xfrm>
              <a:off x="848643" y="903304"/>
              <a:ext cx="5613117" cy="3305987"/>
              <a:chOff x="482883" y="1825655"/>
              <a:chExt cx="5613117" cy="3305987"/>
            </a:xfrm>
          </p:grpSpPr>
          <p:graphicFrame>
            <p:nvGraphicFramePr>
              <p:cNvPr id="79" name="Object 78">
                <a:extLst>
                  <a:ext uri="{FF2B5EF4-FFF2-40B4-BE49-F238E27FC236}">
                    <a16:creationId xmlns:a16="http://schemas.microsoft.com/office/drawing/2014/main" id="{EE249404-15ED-44D4-A190-7C9E9CC66AC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91716205"/>
                  </p:ext>
                </p:extLst>
              </p:nvPr>
            </p:nvGraphicFramePr>
            <p:xfrm>
              <a:off x="1469050" y="3427400"/>
              <a:ext cx="2124457" cy="168970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3" name="Prism 9" r:id="rId4" imgW="3055391" imgH="2430319" progId="Prism9.Document">
                      <p:embed/>
                    </p:oleObj>
                  </mc:Choice>
                  <mc:Fallback>
                    <p:oleObj name="Prism 9" r:id="rId4" imgW="3055391" imgH="2430319" progId="Prism9.Document">
                      <p:embed/>
                      <p:pic>
                        <p:nvPicPr>
                          <p:cNvPr id="79" name="Object 78">
                            <a:extLst>
                              <a:ext uri="{FF2B5EF4-FFF2-40B4-BE49-F238E27FC236}">
                                <a16:creationId xmlns:a16="http://schemas.microsoft.com/office/drawing/2014/main" id="{EE249404-15ED-44D4-A190-7C9E9CC66AC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469050" y="3427400"/>
                            <a:ext cx="2124457" cy="168970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9470114C-3142-4B9F-B828-AD68653C47BB}"/>
                  </a:ext>
                </a:extLst>
              </p:cNvPr>
              <p:cNvGrpSpPr/>
              <p:nvPr/>
            </p:nvGrpSpPr>
            <p:grpSpPr>
              <a:xfrm>
                <a:off x="482883" y="1825655"/>
                <a:ext cx="5613117" cy="1165426"/>
                <a:chOff x="482883" y="1825655"/>
                <a:chExt cx="5613117" cy="1165426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3C5DAE10-92E8-4F54-B3E2-CD97AA1915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90" t="51079" r="14550" b="37635"/>
                <a:stretch/>
              </p:blipFill>
              <p:spPr>
                <a:xfrm>
                  <a:off x="1579323" y="2266782"/>
                  <a:ext cx="3980863" cy="23391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83" name="Picture 182">
                  <a:extLst>
                    <a:ext uri="{FF2B5EF4-FFF2-40B4-BE49-F238E27FC236}">
                      <a16:creationId xmlns:a16="http://schemas.microsoft.com/office/drawing/2014/main" id="{0F171B86-81E8-4E81-B54A-87C31AE461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-12000" contrast="7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03" t="27082" r="5851" b="49611"/>
                <a:stretch/>
              </p:blipFill>
              <p:spPr>
                <a:xfrm>
                  <a:off x="1579323" y="2529136"/>
                  <a:ext cx="3980873" cy="46034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184" name="Straight Connector 183">
                  <a:extLst>
                    <a:ext uri="{FF2B5EF4-FFF2-40B4-BE49-F238E27FC236}">
                      <a16:creationId xmlns:a16="http://schemas.microsoft.com/office/drawing/2014/main" id="{A052AC07-4951-4382-BB09-7DA7C524ED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85098" y="2762324"/>
                  <a:ext cx="398087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5" name="TextBox 184">
                  <a:extLst>
                    <a:ext uri="{FF2B5EF4-FFF2-40B4-BE49-F238E27FC236}">
                      <a16:creationId xmlns:a16="http://schemas.microsoft.com/office/drawing/2014/main" id="{5B1314B1-E092-4746-8B72-11E3CB4686D9}"/>
                    </a:ext>
                  </a:extLst>
                </p:cNvPr>
                <p:cNvSpPr txBox="1"/>
                <p:nvPr/>
              </p:nvSpPr>
              <p:spPr>
                <a:xfrm flipH="1">
                  <a:off x="5519109" y="2519620"/>
                  <a:ext cx="529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FAP</a:t>
                  </a:r>
                </a:p>
              </p:txBody>
            </p: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2388DCF2-62E6-4A63-BF4A-967E03993464}"/>
                    </a:ext>
                  </a:extLst>
                </p:cNvPr>
                <p:cNvGrpSpPr/>
                <p:nvPr/>
              </p:nvGrpSpPr>
              <p:grpSpPr>
                <a:xfrm>
                  <a:off x="1579698" y="1825655"/>
                  <a:ext cx="3980499" cy="481237"/>
                  <a:chOff x="1579698" y="2103541"/>
                  <a:chExt cx="3980499" cy="481237"/>
                </a:xfrm>
              </p:grpSpPr>
              <p:sp>
                <p:nvSpPr>
                  <p:cNvPr id="186" name="TextBox 185">
                    <a:extLst>
                      <a:ext uri="{FF2B5EF4-FFF2-40B4-BE49-F238E27FC236}">
                        <a16:creationId xmlns:a16="http://schemas.microsoft.com/office/drawing/2014/main" id="{EF676DF3-92C9-44C8-BFCE-55917DA6101C}"/>
                      </a:ext>
                    </a:extLst>
                  </p:cNvPr>
                  <p:cNvSpPr txBox="1"/>
                  <p:nvPr/>
                </p:nvSpPr>
                <p:spPr>
                  <a:xfrm>
                    <a:off x="1803506" y="2328347"/>
                    <a:ext cx="53933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</a:t>
                    </a:r>
                  </a:p>
                </p:txBody>
              </p:sp>
              <p:sp>
                <p:nvSpPr>
                  <p:cNvPr id="187" name="TextBox 186">
                    <a:extLst>
                      <a:ext uri="{FF2B5EF4-FFF2-40B4-BE49-F238E27FC236}">
                        <a16:creationId xmlns:a16="http://schemas.microsoft.com/office/drawing/2014/main" id="{ACDB9A94-587A-4631-B352-BF5B98613457}"/>
                      </a:ext>
                    </a:extLst>
                  </p:cNvPr>
                  <p:cNvSpPr txBox="1"/>
                  <p:nvPr/>
                </p:nvSpPr>
                <p:spPr>
                  <a:xfrm>
                    <a:off x="2847482" y="2338557"/>
                    <a:ext cx="58381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TBI</a:t>
                    </a:r>
                  </a:p>
                </p:txBody>
              </p:sp>
              <p:sp>
                <p:nvSpPr>
                  <p:cNvPr id="188" name="TextBox 187">
                    <a:extLst>
                      <a:ext uri="{FF2B5EF4-FFF2-40B4-BE49-F238E27FC236}">
                        <a16:creationId xmlns:a16="http://schemas.microsoft.com/office/drawing/2014/main" id="{66A57B11-01BD-4332-B4ED-89DCBC8556F5}"/>
                      </a:ext>
                    </a:extLst>
                  </p:cNvPr>
                  <p:cNvSpPr txBox="1"/>
                  <p:nvPr/>
                </p:nvSpPr>
                <p:spPr>
                  <a:xfrm>
                    <a:off x="4804770" y="2328346"/>
                    <a:ext cx="58381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TBI</a:t>
                    </a:r>
                  </a:p>
                </p:txBody>
              </p:sp>
              <p:sp>
                <p:nvSpPr>
                  <p:cNvPr id="189" name="TextBox 188">
                    <a:extLst>
                      <a:ext uri="{FF2B5EF4-FFF2-40B4-BE49-F238E27FC236}">
                        <a16:creationId xmlns:a16="http://schemas.microsoft.com/office/drawing/2014/main" id="{BC922D56-0A61-43B9-B77F-7C0E720DD015}"/>
                      </a:ext>
                    </a:extLst>
                  </p:cNvPr>
                  <p:cNvSpPr txBox="1"/>
                  <p:nvPr/>
                </p:nvSpPr>
                <p:spPr>
                  <a:xfrm>
                    <a:off x="3843355" y="2338557"/>
                    <a:ext cx="53933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am</a:t>
                    </a:r>
                  </a:p>
                </p:txBody>
              </p:sp>
              <p:cxnSp>
                <p:nvCxnSpPr>
                  <p:cNvPr id="190" name="Straight Connector 189">
                    <a:extLst>
                      <a:ext uri="{FF2B5EF4-FFF2-40B4-BE49-F238E27FC236}">
                        <a16:creationId xmlns:a16="http://schemas.microsoft.com/office/drawing/2014/main" id="{15A93DC1-273F-42B1-89B9-4E1C6667EA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579698" y="2328214"/>
                    <a:ext cx="1990062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1" name="TextBox 190">
                    <a:extLst>
                      <a:ext uri="{FF2B5EF4-FFF2-40B4-BE49-F238E27FC236}">
                        <a16:creationId xmlns:a16="http://schemas.microsoft.com/office/drawing/2014/main" id="{764D6F63-C09C-4BAB-B765-757815E815D4}"/>
                      </a:ext>
                    </a:extLst>
                  </p:cNvPr>
                  <p:cNvSpPr txBox="1"/>
                  <p:nvPr/>
                </p:nvSpPr>
                <p:spPr>
                  <a:xfrm>
                    <a:off x="2391625" y="2114365"/>
                    <a:ext cx="47439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ale</a:t>
                    </a:r>
                  </a:p>
                </p:txBody>
              </p:sp>
              <p:sp>
                <p:nvSpPr>
                  <p:cNvPr id="192" name="TextBox 191">
                    <a:extLst>
                      <a:ext uri="{FF2B5EF4-FFF2-40B4-BE49-F238E27FC236}">
                        <a16:creationId xmlns:a16="http://schemas.microsoft.com/office/drawing/2014/main" id="{40C88345-EADD-4072-A41F-670EE7DBD864}"/>
                      </a:ext>
                    </a:extLst>
                  </p:cNvPr>
                  <p:cNvSpPr txBox="1"/>
                  <p:nvPr/>
                </p:nvSpPr>
                <p:spPr>
                  <a:xfrm>
                    <a:off x="4278111" y="2103541"/>
                    <a:ext cx="63187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emale</a:t>
                    </a:r>
                  </a:p>
                </p:txBody>
              </p:sp>
              <p:cxnSp>
                <p:nvCxnSpPr>
                  <p:cNvPr id="193" name="Straight Connector 192">
                    <a:extLst>
                      <a:ext uri="{FF2B5EF4-FFF2-40B4-BE49-F238E27FC236}">
                        <a16:creationId xmlns:a16="http://schemas.microsoft.com/office/drawing/2014/main" id="{88910062-7A4C-42EB-AA62-CE6853600C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68169" y="2328214"/>
                    <a:ext cx="189202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94" name="Straight Connector 193">
                  <a:extLst>
                    <a:ext uri="{FF2B5EF4-FFF2-40B4-BE49-F238E27FC236}">
                      <a16:creationId xmlns:a16="http://schemas.microsoft.com/office/drawing/2014/main" id="{25B7CB8F-786B-4B84-8901-088C7DDBC5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12875" y="2272573"/>
                  <a:ext cx="0" cy="716908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2" name="TextBox 181">
                  <a:extLst>
                    <a:ext uri="{FF2B5EF4-FFF2-40B4-BE49-F238E27FC236}">
                      <a16:creationId xmlns:a16="http://schemas.microsoft.com/office/drawing/2014/main" id="{3BCC00FB-0E88-4B2F-B4A1-9F02D828FB77}"/>
                    </a:ext>
                  </a:extLst>
                </p:cNvPr>
                <p:cNvSpPr txBox="1"/>
                <p:nvPr/>
              </p:nvSpPr>
              <p:spPr>
                <a:xfrm>
                  <a:off x="5520201" y="2730995"/>
                  <a:ext cx="57579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</a:t>
                  </a:r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actin </a:t>
                  </a:r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6950B03D-D27D-417E-A6D3-823355B0ECB8}"/>
                    </a:ext>
                  </a:extLst>
                </p:cNvPr>
                <p:cNvSpPr txBox="1"/>
                <p:nvPr/>
              </p:nvSpPr>
              <p:spPr>
                <a:xfrm>
                  <a:off x="482883" y="2286121"/>
                  <a:ext cx="986167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h </a:t>
                  </a:r>
                </a:p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st-mbTBI</a:t>
                  </a:r>
                </a:p>
              </p:txBody>
            </p:sp>
            <p:cxnSp>
              <p:nvCxnSpPr>
                <p:cNvPr id="121" name="Straight Connector 120">
                  <a:extLst>
                    <a:ext uri="{FF2B5EF4-FFF2-40B4-BE49-F238E27FC236}">
                      <a16:creationId xmlns:a16="http://schemas.microsoft.com/office/drawing/2014/main" id="{12CC25AA-D2A3-4271-B6D8-88BCB657C7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37765" y="2274173"/>
                  <a:ext cx="0" cy="716908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>
                  <a:extLst>
                    <a:ext uri="{FF2B5EF4-FFF2-40B4-BE49-F238E27FC236}">
                      <a16:creationId xmlns:a16="http://schemas.microsoft.com/office/drawing/2014/main" id="{A7E13D81-D4F5-4D8A-A800-D33E6EA002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74085" y="2267257"/>
                  <a:ext cx="0" cy="716908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1591BA5B-CD65-4666-8F93-5AE93B89C751}"/>
                    </a:ext>
                  </a:extLst>
                </p:cNvPr>
                <p:cNvSpPr txBox="1"/>
                <p:nvPr/>
              </p:nvSpPr>
              <p:spPr>
                <a:xfrm flipH="1">
                  <a:off x="5519109" y="2282419"/>
                  <a:ext cx="529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BA1</a:t>
                  </a:r>
                </a:p>
              </p:txBody>
            </p:sp>
          </p:grpSp>
          <p:graphicFrame>
            <p:nvGraphicFramePr>
              <p:cNvPr id="204" name="Object 203">
                <a:extLst>
                  <a:ext uri="{FF2B5EF4-FFF2-40B4-BE49-F238E27FC236}">
                    <a16:creationId xmlns:a16="http://schemas.microsoft.com/office/drawing/2014/main" id="{6CA9AA00-45EC-47C3-8518-B54627F108C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46498366"/>
                  </p:ext>
                </p:extLst>
              </p:nvPr>
            </p:nvGraphicFramePr>
            <p:xfrm>
              <a:off x="3569754" y="3441939"/>
              <a:ext cx="2124457" cy="168970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4" name="Prism 9" r:id="rId10" imgW="3055391" imgH="2430319" progId="Prism9.Document">
                      <p:embed/>
                    </p:oleObj>
                  </mc:Choice>
                  <mc:Fallback>
                    <p:oleObj name="Prism 9" r:id="rId10" imgW="3055391" imgH="2430319" progId="Prism9.Document">
                      <p:embed/>
                      <p:pic>
                        <p:nvPicPr>
                          <p:cNvPr id="79" name="Object 78">
                            <a:extLst>
                              <a:ext uri="{FF2B5EF4-FFF2-40B4-BE49-F238E27FC236}">
                                <a16:creationId xmlns:a16="http://schemas.microsoft.com/office/drawing/2014/main" id="{EE249404-15ED-44D4-A190-7C9E9CC66AC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3569754" y="3441939"/>
                            <a:ext cx="2124457" cy="168970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C6F31C43-6E3B-47D0-91D5-68766DC55301}"/>
                </a:ext>
              </a:extLst>
            </p:cNvPr>
            <p:cNvSpPr/>
            <p:nvPr/>
          </p:nvSpPr>
          <p:spPr>
            <a:xfrm>
              <a:off x="1025943" y="4444328"/>
              <a:ext cx="5287393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Representative Western blot and respective densitometry quantification of IBA1 from same blot of GFAP (Fig. 6, A) 6h post-</a:t>
              </a:r>
              <a:r>
                <a:rPr lang="en-US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bTBI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. Probing was done against IBA1 (1:1000; 016-20001;  FUJIFILM Wako pure chemical Corporation). Signals were detected using </a:t>
              </a:r>
              <a:r>
                <a:rPr lang="it-IT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IRDye 800 CW goat anti-rabbit (1:10,000; 926-32211, Li-Cor).</a:t>
              </a:r>
              <a:endParaRPr lang="en-US" sz="1200" dirty="0"/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C5F7C3A-F41D-4936-A317-DCDC1F9090C0}"/>
              </a:ext>
            </a:extLst>
          </p:cNvPr>
          <p:cNvSpPr/>
          <p:nvPr/>
        </p:nvSpPr>
        <p:spPr>
          <a:xfrm>
            <a:off x="529799" y="241442"/>
            <a:ext cx="21788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6.</a:t>
            </a:r>
          </a:p>
        </p:txBody>
      </p:sp>
    </p:spTree>
    <p:extLst>
      <p:ext uri="{BB962C8B-B14F-4D97-AF65-F5344CB8AC3E}">
        <p14:creationId xmlns:p14="http://schemas.microsoft.com/office/powerpoint/2010/main" val="3254563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73</Words>
  <Application>Microsoft Office PowerPoint</Application>
  <PresentationFormat>Widescreen</PresentationFormat>
  <Paragraphs>1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al Viswanathan, Velmurugan</dc:creator>
  <cp:lastModifiedBy>Hubbard, Brad</cp:lastModifiedBy>
  <cp:revision>14</cp:revision>
  <dcterms:created xsi:type="dcterms:W3CDTF">2022-06-09T18:11:15Z</dcterms:created>
  <dcterms:modified xsi:type="dcterms:W3CDTF">2022-06-10T19:19:18Z</dcterms:modified>
</cp:coreProperties>
</file>